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8" d="100"/>
          <a:sy n="88" d="100"/>
        </p:scale>
        <p:origin x="451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6265C-DBDB-4196-9A21-B671F8E4258C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45210-06A2-4D4F-8020-03569F01FE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397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6265C-DBDB-4196-9A21-B671F8E4258C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45210-06A2-4D4F-8020-03569F01FE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1382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6265C-DBDB-4196-9A21-B671F8E4258C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45210-06A2-4D4F-8020-03569F01FE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33080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6265C-DBDB-4196-9A21-B671F8E4258C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45210-06A2-4D4F-8020-03569F01FE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61892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6265C-DBDB-4196-9A21-B671F8E4258C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45210-06A2-4D4F-8020-03569F01FE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6521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6265C-DBDB-4196-9A21-B671F8E4258C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45210-06A2-4D4F-8020-03569F01FE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1988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6265C-DBDB-4196-9A21-B671F8E4258C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45210-06A2-4D4F-8020-03569F01FE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291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6265C-DBDB-4196-9A21-B671F8E4258C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45210-06A2-4D4F-8020-03569F01FE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9155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6265C-DBDB-4196-9A21-B671F8E4258C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45210-06A2-4D4F-8020-03569F01FE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3473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6265C-DBDB-4196-9A21-B671F8E4258C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45210-06A2-4D4F-8020-03569F01FE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6599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06265C-DBDB-4196-9A21-B671F8E4258C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45210-06A2-4D4F-8020-03569F01FE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031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06265C-DBDB-4196-9A21-B671F8E4258C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245210-06A2-4D4F-8020-03569F01FE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4158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9816" y="636183"/>
            <a:ext cx="4764765" cy="27432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86924" y="737770"/>
            <a:ext cx="4764765" cy="27432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6803" y="3944649"/>
            <a:ext cx="4764766" cy="274320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86923" y="3878835"/>
            <a:ext cx="4764765" cy="274320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4322617" y="19255"/>
            <a:ext cx="36838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u="sng" dirty="0"/>
              <a:t>Suppl. Figure </a:t>
            </a:r>
            <a:r>
              <a:rPr lang="en-US" b="1" u="sng" dirty="0" smtClean="0"/>
              <a:t>10</a:t>
            </a:r>
            <a:r>
              <a:rPr lang="en-US" b="1" dirty="0" smtClean="0"/>
              <a:t>. </a:t>
            </a:r>
            <a:r>
              <a:rPr lang="en-US" b="1" dirty="0" err="1" smtClean="0"/>
              <a:t>Heatmap</a:t>
            </a:r>
            <a:r>
              <a:rPr lang="en-US" b="1" dirty="0" smtClean="0"/>
              <a:t> for </a:t>
            </a:r>
            <a:r>
              <a:rPr lang="en-US" b="1" dirty="0" err="1" smtClean="0"/>
              <a:t>piRNA</a:t>
            </a:r>
            <a:endParaRPr lang="en-US" b="1" dirty="0"/>
          </a:p>
        </p:txBody>
      </p:sp>
      <p:sp>
        <p:nvSpPr>
          <p:cNvPr id="2" name="Rectangle 1"/>
          <p:cNvSpPr/>
          <p:nvPr/>
        </p:nvSpPr>
        <p:spPr>
          <a:xfrm>
            <a:off x="1235222" y="345916"/>
            <a:ext cx="278505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/>
              <a:t>Non-smokers vs. Cigarette smokers</a:t>
            </a:r>
          </a:p>
        </p:txBody>
      </p:sp>
      <p:sp>
        <p:nvSpPr>
          <p:cNvPr id="14" name="Rectangle 13"/>
          <p:cNvSpPr/>
          <p:nvPr/>
        </p:nvSpPr>
        <p:spPr>
          <a:xfrm>
            <a:off x="6169068" y="381324"/>
            <a:ext cx="289912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/>
              <a:t>Non-smokers vs. </a:t>
            </a:r>
            <a:r>
              <a:rPr lang="en-US" sz="1400" b="1" u="sng" dirty="0" err="1"/>
              <a:t>Waterpipe</a:t>
            </a:r>
            <a:r>
              <a:rPr lang="en-US" sz="1400" b="1" u="sng" dirty="0"/>
              <a:t> smokers</a:t>
            </a:r>
          </a:p>
        </p:txBody>
      </p:sp>
      <p:sp>
        <p:nvSpPr>
          <p:cNvPr id="15" name="Rectangle 14"/>
          <p:cNvSpPr/>
          <p:nvPr/>
        </p:nvSpPr>
        <p:spPr>
          <a:xfrm>
            <a:off x="1235222" y="3669641"/>
            <a:ext cx="22347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/>
              <a:t>Non-smokers vs. E-cig </a:t>
            </a:r>
            <a:r>
              <a:rPr lang="en-US" sz="1400" b="1" u="sng" dirty="0" smtClean="0"/>
              <a:t>users</a:t>
            </a:r>
            <a:endParaRPr lang="en-US" sz="1400" b="1" u="sng" dirty="0"/>
          </a:p>
        </p:txBody>
      </p:sp>
      <p:sp>
        <p:nvSpPr>
          <p:cNvPr id="16" name="Rectangle 15"/>
          <p:cNvSpPr/>
          <p:nvPr/>
        </p:nvSpPr>
        <p:spPr>
          <a:xfrm>
            <a:off x="6169068" y="3571058"/>
            <a:ext cx="245740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/>
              <a:t>Non-smokers vs. </a:t>
            </a:r>
            <a:r>
              <a:rPr lang="en-US" sz="1400" b="1" u="sng" smtClean="0"/>
              <a:t>Dual </a:t>
            </a:r>
            <a:r>
              <a:rPr lang="en-US" sz="1400" b="1" u="sng" dirty="0"/>
              <a:t>smokers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914027" y="306384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.</a:t>
            </a:r>
            <a:endParaRPr lang="en-US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5877814" y="350897"/>
            <a:ext cx="5018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.</a:t>
            </a:r>
            <a:endParaRPr lang="en-US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869416" y="3649128"/>
            <a:ext cx="365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.</a:t>
            </a:r>
            <a:endParaRPr lang="en-US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5877814" y="3545479"/>
            <a:ext cx="3863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D.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6081327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0508" y="719099"/>
            <a:ext cx="4764765" cy="27432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58600" y="735724"/>
            <a:ext cx="4764765" cy="27432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0507" y="3915391"/>
            <a:ext cx="4764765" cy="27432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1043" y="3865515"/>
            <a:ext cx="4764765" cy="2743200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4595953" y="41360"/>
            <a:ext cx="36838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u="sng" dirty="0"/>
              <a:t>Suppl. </a:t>
            </a:r>
            <a:r>
              <a:rPr lang="en-US" b="1" u="sng"/>
              <a:t>Figure </a:t>
            </a:r>
            <a:r>
              <a:rPr lang="en-US" b="1" u="sng" smtClean="0"/>
              <a:t>10</a:t>
            </a:r>
            <a:r>
              <a:rPr lang="en-US" b="1" smtClean="0"/>
              <a:t>. </a:t>
            </a:r>
            <a:r>
              <a:rPr lang="en-US" b="1" dirty="0" err="1" smtClean="0"/>
              <a:t>Heatmap</a:t>
            </a:r>
            <a:r>
              <a:rPr lang="en-US" b="1" dirty="0" smtClean="0"/>
              <a:t> </a:t>
            </a:r>
            <a:r>
              <a:rPr lang="en-US" b="1" dirty="0"/>
              <a:t>for </a:t>
            </a:r>
            <a:r>
              <a:rPr lang="en-US" b="1" dirty="0" err="1"/>
              <a:t>piRNA</a:t>
            </a:r>
            <a:endParaRPr lang="en-US" b="1" dirty="0"/>
          </a:p>
        </p:txBody>
      </p:sp>
      <p:sp>
        <p:nvSpPr>
          <p:cNvPr id="11" name="Rectangle 10"/>
          <p:cNvSpPr/>
          <p:nvPr/>
        </p:nvSpPr>
        <p:spPr>
          <a:xfrm>
            <a:off x="7111285" y="399049"/>
            <a:ext cx="32444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/>
              <a:t>Cigarette smokers vs. </a:t>
            </a:r>
            <a:r>
              <a:rPr lang="en-US" sz="1400" b="1" u="sng" dirty="0" err="1"/>
              <a:t>Waterpipe</a:t>
            </a:r>
            <a:r>
              <a:rPr lang="en-US" sz="1400" b="1" u="sng" dirty="0"/>
              <a:t> smokers</a:t>
            </a:r>
            <a:endParaRPr lang="en-US" sz="1400" dirty="0"/>
          </a:p>
        </p:txBody>
      </p:sp>
      <p:sp>
        <p:nvSpPr>
          <p:cNvPr id="12" name="Rectangle 11"/>
          <p:cNvSpPr/>
          <p:nvPr/>
        </p:nvSpPr>
        <p:spPr>
          <a:xfrm>
            <a:off x="1400507" y="387852"/>
            <a:ext cx="258000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/>
              <a:t>Cigarette smokers vs. E-cig users</a:t>
            </a:r>
          </a:p>
        </p:txBody>
      </p:sp>
      <p:sp>
        <p:nvSpPr>
          <p:cNvPr id="13" name="Rectangle 12"/>
          <p:cNvSpPr/>
          <p:nvPr/>
        </p:nvSpPr>
        <p:spPr>
          <a:xfrm>
            <a:off x="1400507" y="3558425"/>
            <a:ext cx="280269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/>
              <a:t>Cigarette smokers vs. Dual smokers</a:t>
            </a:r>
          </a:p>
        </p:txBody>
      </p:sp>
      <p:sp>
        <p:nvSpPr>
          <p:cNvPr id="14" name="Rectangle 13"/>
          <p:cNvSpPr/>
          <p:nvPr/>
        </p:nvSpPr>
        <p:spPr>
          <a:xfrm>
            <a:off x="7051257" y="3533486"/>
            <a:ext cx="291676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 err="1"/>
              <a:t>Waterpipe</a:t>
            </a:r>
            <a:r>
              <a:rPr lang="en-US" sz="1400" b="1" u="sng" dirty="0"/>
              <a:t> smokers vs. Dual smokers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095524" y="353971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.</a:t>
            </a:r>
            <a:endParaRPr lang="en-US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6808803" y="382385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.</a:t>
            </a:r>
            <a:endParaRPr lang="en-US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1113905" y="3549535"/>
            <a:ext cx="365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.</a:t>
            </a:r>
            <a:endParaRPr lang="en-US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6758600" y="3498390"/>
            <a:ext cx="532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D.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2900954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76</Words>
  <Application>Microsoft Office PowerPoint</Application>
  <PresentationFormat>Widescreen</PresentationFormat>
  <Paragraphs>1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UR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ngh, Kameshwar</dc:creator>
  <cp:lastModifiedBy>Rahman, Irfan</cp:lastModifiedBy>
  <cp:revision>10</cp:revision>
  <dcterms:created xsi:type="dcterms:W3CDTF">2019-12-08T17:28:23Z</dcterms:created>
  <dcterms:modified xsi:type="dcterms:W3CDTF">2020-06-12T05:19:11Z</dcterms:modified>
</cp:coreProperties>
</file>